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2143080" y="685440"/>
            <a:ext cx="2571840" cy="3429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1E833AF-4092-4F7A-A107-7977630E1C3D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" name="PlaceHolder 1"/>
          <p:cNvSpPr>
            <a:spLocks noGrp="1"/>
          </p:cNvSpPr>
          <p:nvPr>
            <p:ph type="sldImg"/>
          </p:nvPr>
        </p:nvSpPr>
        <p:spPr>
          <a:xfrm>
            <a:off x="2143080" y="685800"/>
            <a:ext cx="2571840" cy="3429000"/>
          </a:xfrm>
          <a:prstGeom prst="rect">
            <a:avLst/>
          </a:prstGeom>
          <a:ln w="0">
            <a:noFill/>
          </a:ln>
        </p:spPr>
      </p:sp>
      <p:sp>
        <p:nvSpPr>
          <p:cNvPr id="52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" name="Slide Number Placeholder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A3BA9AA-F22E-4C77-A23B-3AC856CDA691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3455BB9-44D9-4760-9649-CCFC19EB1224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6143BE5-0C1B-43B7-8F2F-F9719A14DB1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FEE171F-D468-4FD1-BC03-06D38D001101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9B47ACB-6C94-4517-90A8-5DEA93EE4A0F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4A85AA4-9087-4EAE-B838-46AC97DB4E0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2C0C12B-65F7-4E57-9A63-2AFC8EBA5DA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0E1AE5B-508B-4161-AA87-29BBE8910B5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238815B-E36E-4D1F-B779-0F6708A3F7F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CDA10C8-CCE6-45CF-A16C-8D8AF43BD9C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7E3E6D2-B90D-42A7-9952-C40499F1CB0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546113F-F880-4332-BD36-6FCCFE793B2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67F9683-BF51-498E-9E42-281CF5D2103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B9443B4-F816-42A0-808F-73CC41D87365}" type="datetime">
              <a:rPr b="0" lang="en-US" sz="1200" spc="-1" strike="noStrike">
                <a:solidFill>
                  <a:srgbClr val="898989"/>
                </a:solidFill>
                <a:latin typeface="Calibri"/>
              </a:rPr>
              <a:t>08/29/26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E13E3EA-1CA6-4895-88C1-08B45CDAE06A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8" name=""/>
          <p:cNvGraphicFramePr/>
          <p:nvPr/>
        </p:nvGraphicFramePr>
        <p:xfrm>
          <a:off x="228600" y="838080"/>
          <a:ext cx="6477120" cy="5303880"/>
        </p:xfrm>
        <a:graphic>
          <a:graphicData uri="http://schemas.openxmlformats.org/drawingml/2006/table">
            <a:tbl>
              <a:tblPr/>
              <a:tblGrid>
                <a:gridCol w="874800"/>
                <a:gridCol w="1054080"/>
                <a:gridCol w="490320"/>
                <a:gridCol w="731880"/>
                <a:gridCol w="3326040"/>
              </a:tblGrid>
              <a:tr h="365400">
                <a:tc>
                  <a:txBody>
                    <a:bodyPr lIns="39240" rIns="39240" tIns="0" bIns="0" anchor="t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Network ID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9240" marR="392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9240" rIns="39240" tIns="0" bIns="0" anchor="t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Function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9240" marR="392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9240" rIns="39240" tIns="0" bIns="0" anchor="t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Score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9240" marR="392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9240" rIns="39240" tIns="0" bIns="0" anchor="t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Focus Proteins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9240" marR="392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9240" rIns="3924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Proteins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9240" marR="392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280880">
                <a:tc>
                  <a:txBody>
                    <a:bodyPr lIns="39240" rIns="39240" tIns="0" bIns="0" anchor="t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BT474 Network 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9240" marR="392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9240" rIns="39240" tIns="0" bIns="0" anchor="t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Cancer, Cellular compromise, Carbohydrate metabolism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9240" marR="392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9240" rIns="39240" tIns="0" bIns="0" anchor="t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37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9240" marR="392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9240" rIns="39240" tIns="0" bIns="0" anchor="t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15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9240" marR="392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9240" rIns="39240" tIns="0" bIns="0" anchor="t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ABCA2,</a:t>
                      </a: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ACY1</a:t>
                      </a: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,AFG3L2,</a:t>
                      </a: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ARFIP2</a:t>
                      </a: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,ATP11B,ATP13A2,ATP13A5,</a:t>
                      </a: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ATP5B</a:t>
                      </a: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,ATP6V0B,ATPase,</a:t>
                      </a: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CACYBP</a:t>
                      </a: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,CDK2,DDX3Y(includesEG:26900),DHX8,DHX16,</a:t>
                      </a: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DLST</a:t>
                      </a: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,DQX1,FABP5,GH1,HNF4A,</a:t>
                      </a: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HNRNPA2B1</a:t>
                      </a: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,IL1B,MYH9,</a:t>
                      </a: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NDUFA5</a:t>
                      </a: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,NTP,ONECUT1,</a:t>
                      </a: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PABP5</a:t>
                      </a: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,</a:t>
                      </a: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PEBP1</a:t>
                      </a: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,</a:t>
                      </a: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PPP1CA</a:t>
                      </a: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,</a:t>
                      </a: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PSMC2</a:t>
                      </a: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,</a:t>
                      </a: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PSMC4</a:t>
                      </a: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,</a:t>
                      </a: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RAD23B</a:t>
                      </a: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,</a:t>
                      </a: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RPLP0(includesEG:6175)</a:t>
                      </a: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,RSF1,</a:t>
                      </a: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TUBB2C</a:t>
                      </a: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,WRNIP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9240" marR="392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279440">
                <a:tc>
                  <a:txBody>
                    <a:bodyPr lIns="39240" rIns="39240" tIns="0" bIns="0" anchor="t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BT474 Network 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9240" marR="392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9240" rIns="39240" tIns="0" bIns="0" anchor="t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Cell morphology, Embryonic development, Tissue development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9240" marR="392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9240" rIns="39240" tIns="0" bIns="0" anchor="t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2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9240" marR="392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9240" rIns="39240" tIns="0" bIns="0" anchor="t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1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9240" marR="392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9240" rIns="39240" tIns="0" bIns="0" anchor="t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ABLIM2,</a:t>
                      </a: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ACTB</a:t>
                      </a: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,</a:t>
                      </a: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Actin</a:t>
                      </a: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,ActinNrf2,AFAP1,betaestradiol,</a:t>
                      </a: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CALU</a:t>
                      </a: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,</a:t>
                      </a: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CAPZA1</a:t>
                      </a: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,</a:t>
                      </a: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CFL1</a:t>
                      </a: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,ERMN,ESPN,</a:t>
                      </a: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FActin</a:t>
                      </a: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,IGF1R,IPP,</a:t>
                      </a: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LASP1</a:t>
                      </a: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,MAEA,MAP6,MYO16,NEXN,</a:t>
                      </a: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PFN1</a:t>
                      </a: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,PHACTR1,PIK3R1,Pld,PLS1(includesEG:104006),PLS1(includesEG:5357),</a:t>
                      </a: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PMPCB</a:t>
                      </a: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,SAR1B,</a:t>
                      </a: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SEC13</a:t>
                      </a: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,SHROOM3,SMARCA2,SYF2,</a:t>
                      </a: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TUBA1B</a:t>
                      </a: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,</a:t>
                      </a: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UQCRC1</a:t>
                      </a: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,WIPF3,XPO6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9240" marR="392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097280">
                <a:tc>
                  <a:txBody>
                    <a:bodyPr lIns="39240" rIns="39240" tIns="0" bIns="0" anchor="t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SKBR3 Network 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9240" marR="392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9240" rIns="39240" tIns="0" bIns="0" anchor="t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Cellular development,Cell cycle,Gene expression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9240" marR="392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9240" rIns="39240" tIns="0" bIns="0" anchor="t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4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9240" marR="392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9240" rIns="39240" tIns="0" bIns="0" anchor="t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17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9240" marR="392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9240" rIns="39240" tIns="0" bIns="0" anchor="t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ATP,</a:t>
                      </a: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BLVRB</a:t>
                      </a: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,C11ORF51,C16ORF80,CDK2,</a:t>
                      </a: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CSTF1</a:t>
                      </a: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,DDX28,E2F4,EG432798,</a:t>
                      </a: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ENO1</a:t>
                      </a: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,FBXL7,FOS,</a:t>
                      </a: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GLUD1</a:t>
                      </a: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,</a:t>
                      </a: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GNB2L1</a:t>
                      </a: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,GOLT1B,</a:t>
                      </a: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GOT1</a:t>
                      </a: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,HEL308,HNF4A,</a:t>
                      </a: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HNRNPH3</a:t>
                      </a: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,HRAS,</a:t>
                      </a: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IDH1</a:t>
                      </a: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,IER5,INSR,LCMT2,</a:t>
                      </a: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NAPA</a:t>
                      </a: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,</a:t>
                      </a: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PCYT2</a:t>
                      </a: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,</a:t>
                      </a: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PDLIM1</a:t>
                      </a: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,</a:t>
                      </a: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PSMA5</a:t>
                      </a: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,</a:t>
                      </a: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PSMC5</a:t>
                      </a: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,</a:t>
                      </a: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RAB11A</a:t>
                      </a: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,</a:t>
                      </a: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RAB1B</a:t>
                      </a: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,</a:t>
                      </a: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RBM4</a:t>
                      </a: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,</a:t>
                      </a: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SKP1</a:t>
                      </a: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,TMEM126B,TTR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9240" marR="392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280880">
                <a:tc>
                  <a:txBody>
                    <a:bodyPr lIns="39240" rIns="39240" tIns="0" bIns="0" anchor="t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SKBR3 Network 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9240" marR="392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9240" rIns="39240" tIns="0" bIns="0" anchor="t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Cell cycle, Reproductive system development and function, Small molecule biochemistry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9240" marR="392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9240" rIns="39240" tIns="0" bIns="0" anchor="t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27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9240" marR="392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9240" rIns="39240" tIns="0" bIns="0" anchor="t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1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9240" marR="392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9240" rIns="39240" tIns="0" bIns="0" anchor="t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ACSL4,</a:t>
                      </a: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ADK</a:t>
                      </a: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,</a:t>
                      </a: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AKR1A1</a:t>
                      </a: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,CLEC2D(includesEG:113937),</a:t>
                      </a: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CNPY2</a:t>
                      </a: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,DDX18,</a:t>
                      </a: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GNB2</a:t>
                      </a: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,</a:t>
                      </a: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HSPB1</a:t>
                      </a: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,HSPD1,IKBKE,MGST3,MPST,MRPL12,MYBMAPPED,MYC,NARS,</a:t>
                      </a: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NP</a:t>
                      </a: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,</a:t>
                      </a: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PCBP1(includesEG:5093)</a:t>
                      </a: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,PDXK,</a:t>
                      </a: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PGAM1</a:t>
                      </a: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,PLS3,RAGE,RAI14,retinoicacid,RN5S,RPS12,SCPEP1,SFXN1,THOP1,</a:t>
                      </a: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TIMP2</a:t>
                      </a: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,TPD52,</a:t>
                      </a: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TPI1</a:t>
                      </a: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,</a:t>
                      </a: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TSFM</a:t>
                      </a: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,</a:t>
                      </a: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TST</a:t>
                      </a: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,YWHAZ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9240" marR="392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49" name="Rectangle 1"/>
          <p:cNvSpPr/>
          <p:nvPr/>
        </p:nvSpPr>
        <p:spPr>
          <a:xfrm>
            <a:off x="0" y="0"/>
            <a:ext cx="68580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Title 1"/>
          <p:cNvSpPr/>
          <p:nvPr/>
        </p:nvSpPr>
        <p:spPr>
          <a:xfrm>
            <a:off x="228600" y="152280"/>
            <a:ext cx="6400800" cy="609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able III.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Top network associated functions generated using proteins deregulated 1.5-fold or more </a:t>
            </a:r>
            <a:br>
              <a:rPr sz="1200"/>
            </a:b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96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04-09T13:21:08Z</dcterms:created>
  <dc:creator>ykulkarni</dc:creator>
  <dc:description/>
  <dc:language>en-US</dc:language>
  <cp:lastModifiedBy>David Klinke</cp:lastModifiedBy>
  <dcterms:modified xsi:type="dcterms:W3CDTF">2010-06-11T21:52:18Z</dcterms:modified>
  <cp:revision>58</cp:revision>
  <dc:subject/>
  <dc:title>Slide 1</dc:title>
</cp:coreProperties>
</file>